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12192000" cy="1440021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4" autoAdjust="0"/>
    <p:restoredTop sz="95494" autoAdjust="0"/>
  </p:normalViewPr>
  <p:slideViewPr>
    <p:cSldViewPr snapToGrid="0">
      <p:cViewPr varScale="1">
        <p:scale>
          <a:sx n="41" d="100"/>
          <a:sy n="41" d="100"/>
        </p:scale>
        <p:origin x="23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DC292E-CA66-4DEE-A07A-76CF31F0C8E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143000"/>
            <a:ext cx="2613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ED13A2-6E1D-4F71-98DF-2677D19366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6250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6703"/>
            <a:ext cx="10363200" cy="50134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63446"/>
            <a:ext cx="9144000" cy="34767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8716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318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6678"/>
            <a:ext cx="2628900" cy="1220351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6678"/>
            <a:ext cx="7734300" cy="1220351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483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1384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0057"/>
            <a:ext cx="10515600" cy="599008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36813"/>
            <a:ext cx="10515600" cy="31500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9454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3390"/>
            <a:ext cx="5181600" cy="913680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3390"/>
            <a:ext cx="5181600" cy="913680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5406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6681"/>
            <a:ext cx="10515600" cy="278337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0053"/>
            <a:ext cx="5157787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0078"/>
            <a:ext cx="5157787" cy="773678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0053"/>
            <a:ext cx="5183188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0078"/>
            <a:ext cx="5183188" cy="773678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9526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243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2996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3367"/>
            <a:ext cx="6172200" cy="1023348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872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3367"/>
            <a:ext cx="6172200" cy="1023348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530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6681"/>
            <a:ext cx="105156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3390"/>
            <a:ext cx="105156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5495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2.tif"/><Relationship Id="rId7" Type="http://schemas.microsoft.com/office/2007/relationships/hdphoto" Target="../media/hdphoto1.wdp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5" t="39422" r="29991" b="45264"/>
          <a:stretch/>
        </p:blipFill>
        <p:spPr>
          <a:xfrm>
            <a:off x="6066797" y="11259610"/>
            <a:ext cx="6020020" cy="827753"/>
          </a:xfrm>
          <a:prstGeom prst="rect">
            <a:avLst/>
          </a:prstGeom>
        </p:spPr>
      </p:pic>
      <p:pic>
        <p:nvPicPr>
          <p:cNvPr id="18" name="그림 17"/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22" t="37257" r="21927" b="35184"/>
          <a:stretch/>
        </p:blipFill>
        <p:spPr>
          <a:xfrm>
            <a:off x="6368936" y="9655564"/>
            <a:ext cx="5476252" cy="1378765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310" y="2106652"/>
            <a:ext cx="5554700" cy="389187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90814" y="912669"/>
            <a:ext cx="17499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/>
              <a:t>Figure 2. B</a:t>
            </a:r>
            <a:endParaRPr lang="ko-KR" altLang="en-US" sz="28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0004995" y="9996030"/>
            <a:ext cx="1354781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/>
              <a:t>HDF+EGCG</a:t>
            </a:r>
          </a:p>
          <a:p>
            <a:r>
              <a:rPr lang="el-GR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</a:t>
            </a:r>
            <a:r>
              <a:rPr lang="en-US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355" dirty="0"/>
              <a:t>MMP-9</a:t>
            </a: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05" t="35141" r="27951" b="32942"/>
          <a:stretch/>
        </p:blipFill>
        <p:spPr>
          <a:xfrm>
            <a:off x="4716885" y="6544737"/>
            <a:ext cx="6526286" cy="1931265"/>
          </a:xfrm>
          <a:prstGeom prst="rect">
            <a:avLst/>
          </a:prstGeom>
        </p:spPr>
      </p:pic>
      <p:sp>
        <p:nvSpPr>
          <p:cNvPr id="8" name="직사각형 7"/>
          <p:cNvSpPr/>
          <p:nvPr/>
        </p:nvSpPr>
        <p:spPr>
          <a:xfrm>
            <a:off x="8552598" y="7014087"/>
            <a:ext cx="2690572" cy="84191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11" name="TextBox 10"/>
          <p:cNvSpPr txBox="1"/>
          <p:nvPr/>
        </p:nvSpPr>
        <p:spPr>
          <a:xfrm>
            <a:off x="11243170" y="7066601"/>
            <a:ext cx="1149610" cy="7178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/>
              <a:t>HDF+EGCG</a:t>
            </a:r>
          </a:p>
          <a:p>
            <a:r>
              <a:rPr lang="en-US" altLang="ko-KR" sz="1355" dirty="0"/>
              <a:t>Pro-MMP2</a:t>
            </a:r>
          </a:p>
          <a:p>
            <a:r>
              <a:rPr lang="en-US" altLang="ko-KR" sz="1355" dirty="0"/>
              <a:t>Active-MMP2</a:t>
            </a:r>
            <a:endParaRPr lang="ko-KR" altLang="en-US" sz="1355" dirty="0"/>
          </a:p>
        </p:txBody>
      </p:sp>
      <p:sp>
        <p:nvSpPr>
          <p:cNvPr id="12" name="TextBox 11"/>
          <p:cNvSpPr txBox="1"/>
          <p:nvPr/>
        </p:nvSpPr>
        <p:spPr>
          <a:xfrm>
            <a:off x="10513449" y="11546892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/>
              <a:t>HDF+EGCG</a:t>
            </a:r>
          </a:p>
          <a:p>
            <a:r>
              <a:rPr lang="el-GR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</a:t>
            </a:r>
            <a:r>
              <a:rPr lang="en-US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355" dirty="0"/>
              <a:t>MMP-2</a:t>
            </a:r>
            <a:endParaRPr lang="ko-KR" altLang="en-US" sz="1355" dirty="0"/>
          </a:p>
        </p:txBody>
      </p:sp>
      <p:sp>
        <p:nvSpPr>
          <p:cNvPr id="14" name="직사각형 13"/>
          <p:cNvSpPr/>
          <p:nvPr/>
        </p:nvSpPr>
        <p:spPr>
          <a:xfrm>
            <a:off x="3500276" y="2894187"/>
            <a:ext cx="2286074" cy="50655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17" name="TextBox 16"/>
          <p:cNvSpPr txBox="1"/>
          <p:nvPr/>
        </p:nvSpPr>
        <p:spPr>
          <a:xfrm>
            <a:off x="5834458" y="2947895"/>
            <a:ext cx="1354781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+EGCG</a:t>
            </a:r>
            <a:endParaRPr lang="en-US" altLang="ko-KR" sz="1355" dirty="0"/>
          </a:p>
          <a:p>
            <a:r>
              <a:rPr lang="en-US" altLang="ko-KR" sz="1355" dirty="0"/>
              <a:t>MMP-9</a:t>
            </a:r>
          </a:p>
        </p:txBody>
      </p:sp>
      <p:sp>
        <p:nvSpPr>
          <p:cNvPr id="16" name="직사각형 15"/>
          <p:cNvSpPr/>
          <p:nvPr/>
        </p:nvSpPr>
        <p:spPr>
          <a:xfrm>
            <a:off x="7534379" y="11546892"/>
            <a:ext cx="2286074" cy="50655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20" name="직사각형 19"/>
          <p:cNvSpPr/>
          <p:nvPr/>
        </p:nvSpPr>
        <p:spPr>
          <a:xfrm>
            <a:off x="7280652" y="10028301"/>
            <a:ext cx="2286074" cy="50655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pic>
        <p:nvPicPr>
          <p:cNvPr id="24" name="그림 17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6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7796" t="30447" r="37139" b="39976"/>
          <a:stretch/>
        </p:blipFill>
        <p:spPr bwMode="auto">
          <a:xfrm>
            <a:off x="590814" y="10557443"/>
            <a:ext cx="4780468" cy="1128986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/>
        </p:spPr>
      </p:pic>
      <p:sp>
        <p:nvSpPr>
          <p:cNvPr id="25" name="직사각형 24"/>
          <p:cNvSpPr/>
          <p:nvPr/>
        </p:nvSpPr>
        <p:spPr>
          <a:xfrm>
            <a:off x="1828339" y="11034329"/>
            <a:ext cx="2286074" cy="50655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26" name="TextBox 25"/>
          <p:cNvSpPr txBox="1"/>
          <p:nvPr/>
        </p:nvSpPr>
        <p:spPr>
          <a:xfrm>
            <a:off x="4334482" y="11044401"/>
            <a:ext cx="1354781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+EGCG</a:t>
            </a:r>
            <a:endParaRPr lang="en-US" altLang="ko-KR" sz="1355" dirty="0"/>
          </a:p>
          <a:p>
            <a:r>
              <a:rPr lang="el-GR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</a:t>
            </a:r>
            <a:r>
              <a:rPr lang="en-US" altLang="ko-KR" sz="1355" dirty="0"/>
              <a:t>MMP-2</a:t>
            </a:r>
          </a:p>
        </p:txBody>
      </p:sp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76" t="43344" r="36548" b="41341"/>
          <a:stretch/>
        </p:blipFill>
        <p:spPr>
          <a:xfrm rot="10800000">
            <a:off x="1171954" y="8722967"/>
            <a:ext cx="3232599" cy="725685"/>
          </a:xfrm>
          <a:prstGeom prst="rect">
            <a:avLst/>
          </a:prstGeom>
        </p:spPr>
      </p:pic>
      <p:sp>
        <p:nvSpPr>
          <p:cNvPr id="23" name="직사각형 22"/>
          <p:cNvSpPr/>
          <p:nvPr/>
        </p:nvSpPr>
        <p:spPr>
          <a:xfrm>
            <a:off x="1718021" y="8802709"/>
            <a:ext cx="2286074" cy="50655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27" name="TextBox 26"/>
          <p:cNvSpPr txBox="1"/>
          <p:nvPr/>
        </p:nvSpPr>
        <p:spPr>
          <a:xfrm>
            <a:off x="4391433" y="8743436"/>
            <a:ext cx="1354781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+EGCG</a:t>
            </a:r>
            <a:endParaRPr lang="en-US" altLang="ko-KR" sz="1355" dirty="0"/>
          </a:p>
          <a:p>
            <a:r>
              <a:rPr lang="en-US" altLang="ko-KR" sz="1355" dirty="0"/>
              <a:t>Mmp-9</a:t>
            </a:r>
          </a:p>
        </p:txBody>
      </p:sp>
      <p:pic>
        <p:nvPicPr>
          <p:cNvPr id="28" name="그림 27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2351" t="45033" r="36164" b="44728"/>
          <a:stretch/>
        </p:blipFill>
        <p:spPr bwMode="auto">
          <a:xfrm>
            <a:off x="590814" y="7647244"/>
            <a:ext cx="2728195" cy="418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3443142" y="7487387"/>
            <a:ext cx="1149610" cy="7178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 err="1"/>
              <a:t>HaCaT+EGCG</a:t>
            </a:r>
            <a:endParaRPr lang="en-US" altLang="ko-KR" sz="1355" dirty="0"/>
          </a:p>
          <a:p>
            <a:r>
              <a:rPr lang="en-US" altLang="ko-KR" sz="1355" dirty="0"/>
              <a:t>Pro-MMP2</a:t>
            </a:r>
          </a:p>
          <a:p>
            <a:r>
              <a:rPr lang="en-US" altLang="ko-KR" sz="1355" dirty="0"/>
              <a:t>Active-MMP2</a:t>
            </a:r>
            <a:endParaRPr lang="ko-KR" altLang="en-US" sz="1355" dirty="0"/>
          </a:p>
        </p:txBody>
      </p:sp>
      <p:sp>
        <p:nvSpPr>
          <p:cNvPr id="30" name="직사각형 29"/>
          <p:cNvSpPr/>
          <p:nvPr/>
        </p:nvSpPr>
        <p:spPr>
          <a:xfrm>
            <a:off x="946586" y="7577397"/>
            <a:ext cx="2286074" cy="50655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</p:spTree>
    <p:extLst>
      <p:ext uri="{BB962C8B-B14F-4D97-AF65-F5344CB8AC3E}">
        <p14:creationId xmlns:p14="http://schemas.microsoft.com/office/powerpoint/2010/main" val="1469857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3</TotalTime>
  <Words>23</Words>
  <Application>Microsoft Office PowerPoint</Application>
  <PresentationFormat>사용자 지정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2</cp:revision>
  <dcterms:created xsi:type="dcterms:W3CDTF">2020-06-04T05:19:59Z</dcterms:created>
  <dcterms:modified xsi:type="dcterms:W3CDTF">2020-08-12T05:05:59Z</dcterms:modified>
</cp:coreProperties>
</file>